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4" d="100"/>
          <a:sy n="74" d="100"/>
        </p:scale>
        <p:origin x="-1530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5081E-26B8-476A-B576-380A6AC26EB7}" type="datetimeFigureOut">
              <a:rPr lang="en-US" smtClean="0"/>
              <a:t>1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197BE-C81B-424C-91BA-87468B7D4C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12890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5081E-26B8-476A-B576-380A6AC26EB7}" type="datetimeFigureOut">
              <a:rPr lang="en-US" smtClean="0"/>
              <a:t>1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197BE-C81B-424C-91BA-87468B7D4C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09008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5081E-26B8-476A-B576-380A6AC26EB7}" type="datetimeFigureOut">
              <a:rPr lang="en-US" smtClean="0"/>
              <a:t>1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197BE-C81B-424C-91BA-87468B7D4C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09179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5081E-26B8-476A-B576-380A6AC26EB7}" type="datetimeFigureOut">
              <a:rPr lang="en-US" smtClean="0"/>
              <a:t>1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197BE-C81B-424C-91BA-87468B7D4C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58582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5081E-26B8-476A-B576-380A6AC26EB7}" type="datetimeFigureOut">
              <a:rPr lang="en-US" smtClean="0"/>
              <a:t>1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197BE-C81B-424C-91BA-87468B7D4C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99883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5081E-26B8-476A-B576-380A6AC26EB7}" type="datetimeFigureOut">
              <a:rPr lang="en-US" smtClean="0"/>
              <a:t>1/1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197BE-C81B-424C-91BA-87468B7D4C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74394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5081E-26B8-476A-B576-380A6AC26EB7}" type="datetimeFigureOut">
              <a:rPr lang="en-US" smtClean="0"/>
              <a:t>1/11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197BE-C81B-424C-91BA-87468B7D4C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01441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5081E-26B8-476A-B576-380A6AC26EB7}" type="datetimeFigureOut">
              <a:rPr lang="en-US" smtClean="0"/>
              <a:t>1/11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197BE-C81B-424C-91BA-87468B7D4C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72450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5081E-26B8-476A-B576-380A6AC26EB7}" type="datetimeFigureOut">
              <a:rPr lang="en-US" smtClean="0"/>
              <a:t>1/11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197BE-C81B-424C-91BA-87468B7D4C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0130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5081E-26B8-476A-B576-380A6AC26EB7}" type="datetimeFigureOut">
              <a:rPr lang="en-US" smtClean="0"/>
              <a:t>1/1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197BE-C81B-424C-91BA-87468B7D4C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79223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5081E-26B8-476A-B576-380A6AC26EB7}" type="datetimeFigureOut">
              <a:rPr lang="en-US" smtClean="0"/>
              <a:t>1/1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197BE-C81B-424C-91BA-87468B7D4C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12860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C5081E-26B8-476A-B576-380A6AC26EB7}" type="datetimeFigureOut">
              <a:rPr lang="en-US" smtClean="0"/>
              <a:t>1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4197BE-C81B-424C-91BA-87468B7D4C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40181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6000" y="457200"/>
            <a:ext cx="4572000" cy="457200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1905000" y="5224357"/>
            <a:ext cx="617005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Figure 3: ROC curve for predicting SVR for PR subjects in using MRM data.  The AUC for this curve is 0.8.</a:t>
            </a:r>
          </a:p>
        </p:txBody>
      </p:sp>
    </p:spTree>
    <p:extLst>
      <p:ext uri="{BB962C8B-B14F-4D97-AF65-F5344CB8AC3E}">
        <p14:creationId xmlns:p14="http://schemas.microsoft.com/office/powerpoint/2010/main" val="42599953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4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Vertex Pharmaceuticals Incorporate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istrator</dc:creator>
  <cp:lastModifiedBy>Administrator</cp:lastModifiedBy>
  <cp:revision>1</cp:revision>
  <dcterms:created xsi:type="dcterms:W3CDTF">2015-01-11T19:42:54Z</dcterms:created>
  <dcterms:modified xsi:type="dcterms:W3CDTF">2015-01-11T19:44:16Z</dcterms:modified>
</cp:coreProperties>
</file>